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erat Bagha" initials="MB" lastIdx="7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B0A5"/>
    <a:srgbClr val="2F5597"/>
    <a:srgbClr val="007098"/>
    <a:srgbClr val="FFC000"/>
    <a:srgbClr val="E6E6E6"/>
    <a:srgbClr val="00B050"/>
    <a:srgbClr val="0C5882"/>
    <a:srgbClr val="0B5882"/>
    <a:srgbClr val="007097"/>
    <a:srgbClr val="FFD96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50" d="100"/>
          <a:sy n="150" d="100"/>
        </p:scale>
        <p:origin x="-112" y="-55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commentAuthors" Target="commentAuthors.xml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91B3A52-9C11-DE48-8CC0-104A647BC746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D895EF6-8338-224C-8731-9E89DD4A1B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75809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E0605837-44FE-4697-A465-ED5A13A929B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="" xmlns:a16="http://schemas.microsoft.com/office/drawing/2014/main" id="{DB815682-DA19-4813-AD13-4EC0E644810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16834218-596C-46D8-8157-9050CC141E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D2D111F2-9794-486E-90E2-63D5D67E66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8258C388-3162-4C73-A1C6-0C75695F09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49197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660DC4C4-FE14-4460-8232-F04345519E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865F2FB6-87E8-43CE-A50E-707DA4F6C42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11BBEAD2-75C4-47FB-939C-32535B3B38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17CEBC50-A90E-4F43-ADB4-258787EB31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7B6021C3-ECF0-4126-A815-298067FB41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91242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="" xmlns:a16="http://schemas.microsoft.com/office/drawing/2014/main" id="{0B6D50D9-819A-43F1-A92F-C7BF3A538C4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B374FDFA-E6F6-4812-BACA-6E54FE4D74D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28B9E568-8CB5-45DC-8E8A-9EDC71C6A9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F373664B-7588-4585-BD0C-1E6E11D027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5FC39804-BA91-4EA1-80E1-6BB89904CC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32145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DD65E8AD-FEC3-46A1-9F7F-525FFB3331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C09381BB-97E5-4DE6-B969-FAF52D16C51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FB3C86E2-A2EF-4601-BFDB-31B0FEF1C4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BFFC0143-D542-4E5F-9773-301F1BD57E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4B6FC666-DFBD-448D-B7CE-04E5DF7032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91539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99CB79B4-D0B3-4B86-A059-94B712EC51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876AB63C-6A3C-4E17-836A-5F006C416D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5319F62D-10B6-4C87-AAD7-75185A43BA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053764DF-2E6A-48B1-A782-1133B1FB25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0191A2BF-A193-43FE-BD09-C21FD079AB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30192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E06F5658-FB35-4144-8BD4-74EEB671DD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F72B149B-3C2A-4FB5-A239-1D7D8F7229A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A5BCC1F6-0FF7-4A2C-A584-2242DC21FC7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E18F72D4-66EB-4D65-B6CB-C5893BBF42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E1FA55F2-32F4-4CB7-B59E-B20D768006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26B707D9-514F-43C1-9166-681A55DBAC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30137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D5E1F58B-E858-4F5A-8307-E25749AA06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948945E2-A55C-4EF4-99A5-E9D94C2C83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94D21E10-4E4A-4A9B-8665-CC047E7902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="" xmlns:a16="http://schemas.microsoft.com/office/drawing/2014/main" id="{714CC3FC-2497-409F-8AC3-61293C5ABF9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="" xmlns:a16="http://schemas.microsoft.com/office/drawing/2014/main" id="{E6C7CB3D-6B75-457C-8C17-721BA068A3F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="" xmlns:a16="http://schemas.microsoft.com/office/drawing/2014/main" id="{AEDC7E2F-B0D5-464A-BE2C-29C3B56D83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="" xmlns:a16="http://schemas.microsoft.com/office/drawing/2014/main" id="{83EF950B-3973-427A-AE34-5CED434A02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="" xmlns:a16="http://schemas.microsoft.com/office/drawing/2014/main" id="{D6C1A0E0-4B27-4E11-AA50-1CCFA4B771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9480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8198F535-A3A4-4082-92F6-3DE35B2002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="" xmlns:a16="http://schemas.microsoft.com/office/drawing/2014/main" id="{05710233-981B-4341-9BDC-B036BF537C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="" xmlns:a16="http://schemas.microsoft.com/office/drawing/2014/main" id="{AE97D9FD-BA35-45C3-9FD6-46C4269441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="" xmlns:a16="http://schemas.microsoft.com/office/drawing/2014/main" id="{38DC67DE-2F0B-4B18-8F06-9EDDF18FF2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19064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="" xmlns:a16="http://schemas.microsoft.com/office/drawing/2014/main" id="{EB8F7090-1EE7-47F3-B760-2C61F9D74D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="" xmlns:a16="http://schemas.microsoft.com/office/drawing/2014/main" id="{0B690DB5-9534-4AD8-8550-0DBCB427B7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="" xmlns:a16="http://schemas.microsoft.com/office/drawing/2014/main" id="{15480695-A8C6-4615-818D-A068CB5D3C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55419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5DCFD880-C7BC-4A9F-9284-51D0CC1018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1F52F9D1-E005-4C9B-9E13-AFDF44196B4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6F2F25E1-1CDE-4434-8B92-53DDA6B2C9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0F8016F1-B9EF-4838-A85C-74986DCC5C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431C4F04-F159-453E-A6B9-B55DFBD56F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2E565885-8DD0-4ABA-82EA-FD85906A9B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14819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5F2502AA-F3DC-4104-92FF-0DA5A51935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="" xmlns:a16="http://schemas.microsoft.com/office/drawing/2014/main" id="{591FE64B-A526-465E-A981-B0BAC54252C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74E23C09-CF58-42B5-A10F-7B10E1DE0C0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D4E10560-47AE-4258-B707-72DDCF5524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D8BC694B-5031-4723-B9A3-F1179FCECB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AF0E08D3-B771-4554-A70D-47A5503454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0248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="" xmlns:a16="http://schemas.microsoft.com/office/drawing/2014/main" id="{376867A7-BD58-4E51-95DB-58B88D079A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D3A05465-645A-4AC0-B322-1A4891808D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3171DFF0-7F94-4D7A-AEDE-45F3DFCD42F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8575E4-54DD-4A6D-86A1-959914E18DA3}" type="datetimeFigureOut">
              <a:rPr lang="en-US" smtClean="0"/>
              <a:t>26/0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8DCA8706-B7AA-43F1-A378-8AA892861D0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66FEA253-09BA-41BF-ADCE-61F3048022A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D2C157-BF76-42F6-B785-93C4E75F2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81865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4" name="Straight Connector 43"/>
          <p:cNvCxnSpPr/>
          <p:nvPr/>
        </p:nvCxnSpPr>
        <p:spPr>
          <a:xfrm>
            <a:off x="5801880" y="5355665"/>
            <a:ext cx="575" cy="21788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74"/>
          <p:cNvCxnSpPr/>
          <p:nvPr/>
        </p:nvCxnSpPr>
        <p:spPr>
          <a:xfrm flipH="1">
            <a:off x="3790860" y="5558473"/>
            <a:ext cx="284809" cy="2856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/>
          <p:cNvCxnSpPr/>
          <p:nvPr/>
        </p:nvCxnSpPr>
        <p:spPr>
          <a:xfrm flipV="1">
            <a:off x="3979090" y="3364111"/>
            <a:ext cx="234494" cy="142153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2" name="Straight Connector 71"/>
          <p:cNvCxnSpPr/>
          <p:nvPr/>
        </p:nvCxnSpPr>
        <p:spPr>
          <a:xfrm>
            <a:off x="2907629" y="3390965"/>
            <a:ext cx="219432" cy="13249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/>
          <p:cNvCxnSpPr/>
          <p:nvPr/>
        </p:nvCxnSpPr>
        <p:spPr>
          <a:xfrm>
            <a:off x="2933901" y="1987925"/>
            <a:ext cx="219432" cy="13249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>
            <a:off x="3988749" y="2733668"/>
            <a:ext cx="199136" cy="102586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/>
          <p:cNvCxnSpPr/>
          <p:nvPr/>
        </p:nvCxnSpPr>
        <p:spPr>
          <a:xfrm flipH="1">
            <a:off x="4716372" y="2400486"/>
            <a:ext cx="49843" cy="19162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/>
          <p:cNvCxnSpPr/>
          <p:nvPr/>
        </p:nvCxnSpPr>
        <p:spPr>
          <a:xfrm flipH="1">
            <a:off x="8550593" y="3547604"/>
            <a:ext cx="207072" cy="11165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/>
          <p:cNvCxnSpPr/>
          <p:nvPr/>
        </p:nvCxnSpPr>
        <p:spPr>
          <a:xfrm flipH="1" flipV="1">
            <a:off x="7386806" y="3374360"/>
            <a:ext cx="199542" cy="93273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/>
          <p:cNvCxnSpPr/>
          <p:nvPr/>
        </p:nvCxnSpPr>
        <p:spPr>
          <a:xfrm flipH="1">
            <a:off x="8536106" y="2308739"/>
            <a:ext cx="247832" cy="3227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 flipH="1">
            <a:off x="6950693" y="2221823"/>
            <a:ext cx="22373" cy="33324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 flipH="1">
            <a:off x="7388934" y="2699867"/>
            <a:ext cx="207072" cy="11165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>
            <a:off x="5809279" y="4109854"/>
            <a:ext cx="575" cy="21788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 flipH="1">
            <a:off x="6304538" y="3361402"/>
            <a:ext cx="209774" cy="89627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H="1" flipV="1">
            <a:off x="5094587" y="3356573"/>
            <a:ext cx="221316" cy="8697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 flipH="1" flipV="1">
            <a:off x="6321029" y="4972172"/>
            <a:ext cx="260888" cy="93771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Oval 1"/>
          <p:cNvSpPr>
            <a:spLocks noChangeAspect="1"/>
          </p:cNvSpPr>
          <p:nvPr/>
        </p:nvSpPr>
        <p:spPr>
          <a:xfrm>
            <a:off x="4108283" y="2580889"/>
            <a:ext cx="1079999" cy="1079999"/>
          </a:xfrm>
          <a:prstGeom prst="ellipse">
            <a:avLst/>
          </a:prstGeom>
          <a:solidFill>
            <a:schemeClr val="accent2">
              <a:lumMod val="60000"/>
              <a:lumOff val="4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wrap="none" lIns="0" tIns="0" rIns="0" bIns="0" rtlCol="0" anchor="ctr"/>
          <a:lstStyle/>
          <a:p>
            <a:pPr algn="ctr"/>
            <a:r>
              <a:rPr lang="en-GB" sz="1100">
                <a:solidFill>
                  <a:schemeClr val="tx1"/>
                </a:solidFill>
                <a:latin typeface="Arial"/>
                <a:cs typeface="Arial"/>
              </a:rPr>
              <a:t>Opportunities</a:t>
            </a:r>
          </a:p>
        </p:txBody>
      </p:sp>
      <p:sp>
        <p:nvSpPr>
          <p:cNvPr id="3" name="Oval 2"/>
          <p:cNvSpPr>
            <a:spLocks noChangeAspect="1"/>
          </p:cNvSpPr>
          <p:nvPr/>
        </p:nvSpPr>
        <p:spPr>
          <a:xfrm>
            <a:off x="6425180" y="2559901"/>
            <a:ext cx="1080000" cy="1080000"/>
          </a:xfrm>
          <a:prstGeom prst="ellipse">
            <a:avLst/>
          </a:prstGeom>
          <a:solidFill>
            <a:schemeClr val="accent1">
              <a:lumMod val="60000"/>
              <a:lumOff val="4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100">
                <a:solidFill>
                  <a:srgbClr val="000000"/>
                </a:solidFill>
                <a:latin typeface="Arial"/>
                <a:cs typeface="Arial"/>
              </a:rPr>
              <a:t>Challenges</a:t>
            </a:r>
          </a:p>
        </p:txBody>
      </p:sp>
      <p:sp>
        <p:nvSpPr>
          <p:cNvPr id="4" name="Oval 3"/>
          <p:cNvSpPr>
            <a:spLocks noChangeAspect="1"/>
          </p:cNvSpPr>
          <p:nvPr/>
        </p:nvSpPr>
        <p:spPr>
          <a:xfrm>
            <a:off x="5262593" y="3052168"/>
            <a:ext cx="1080000" cy="1080000"/>
          </a:xfrm>
          <a:prstGeom prst="ellipse">
            <a:avLst/>
          </a:prstGeom>
          <a:solidFill>
            <a:srgbClr val="00B050">
              <a:alpha val="49804"/>
            </a:srgb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100" b="1" dirty="0">
                <a:solidFill>
                  <a:srgbClr val="000000"/>
                </a:solidFill>
                <a:latin typeface="Arial"/>
                <a:cs typeface="Arial"/>
              </a:rPr>
              <a:t>Patients/ Parents/ Caregivers</a:t>
            </a:r>
          </a:p>
        </p:txBody>
      </p:sp>
      <p:sp>
        <p:nvSpPr>
          <p:cNvPr id="5" name="Oval 4"/>
          <p:cNvSpPr>
            <a:spLocks noChangeAspect="1"/>
          </p:cNvSpPr>
          <p:nvPr/>
        </p:nvSpPr>
        <p:spPr>
          <a:xfrm>
            <a:off x="5270679" y="4311087"/>
            <a:ext cx="1080000" cy="108000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100" dirty="0">
                <a:solidFill>
                  <a:srgbClr val="000000"/>
                </a:solidFill>
                <a:latin typeface="Arial"/>
                <a:cs typeface="Arial"/>
              </a:rPr>
              <a:t>eHealth Tools</a:t>
            </a:r>
          </a:p>
        </p:txBody>
      </p:sp>
      <p:sp>
        <p:nvSpPr>
          <p:cNvPr id="6" name="Oval 5"/>
          <p:cNvSpPr>
            <a:spLocks noChangeAspect="1"/>
          </p:cNvSpPr>
          <p:nvPr/>
        </p:nvSpPr>
        <p:spPr>
          <a:xfrm>
            <a:off x="4308597" y="1347541"/>
            <a:ext cx="1080000" cy="1080000"/>
          </a:xfrm>
          <a:prstGeom prst="ellipse">
            <a:avLst/>
          </a:prstGeom>
          <a:solidFill>
            <a:schemeClr val="accent2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100">
                <a:solidFill>
                  <a:srgbClr val="000000"/>
                </a:solidFill>
                <a:latin typeface="Arial"/>
                <a:cs typeface="Arial"/>
              </a:rPr>
              <a:t>Education</a:t>
            </a:r>
          </a:p>
        </p:txBody>
      </p:sp>
      <p:sp>
        <p:nvSpPr>
          <p:cNvPr id="7" name="Oval 6"/>
          <p:cNvSpPr>
            <a:spLocks noChangeAspect="1"/>
          </p:cNvSpPr>
          <p:nvPr/>
        </p:nvSpPr>
        <p:spPr>
          <a:xfrm>
            <a:off x="3019402" y="1924857"/>
            <a:ext cx="1080000" cy="1080000"/>
          </a:xfrm>
          <a:prstGeom prst="ellipse">
            <a:avLst/>
          </a:prstGeom>
          <a:solidFill>
            <a:schemeClr val="accent2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100">
                <a:solidFill>
                  <a:srgbClr val="000000"/>
                </a:solidFill>
                <a:latin typeface="Arial"/>
                <a:cs typeface="Arial"/>
              </a:rPr>
              <a:t>Clinical/ Diagnostic</a:t>
            </a:r>
          </a:p>
        </p:txBody>
      </p:sp>
      <p:sp>
        <p:nvSpPr>
          <p:cNvPr id="8" name="Oval 7"/>
          <p:cNvSpPr>
            <a:spLocks noChangeAspect="1"/>
          </p:cNvSpPr>
          <p:nvPr/>
        </p:nvSpPr>
        <p:spPr>
          <a:xfrm>
            <a:off x="3019404" y="3223812"/>
            <a:ext cx="1080000" cy="1080000"/>
          </a:xfrm>
          <a:prstGeom prst="ellipse">
            <a:avLst/>
          </a:prstGeom>
          <a:solidFill>
            <a:schemeClr val="accent2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100" dirty="0">
                <a:solidFill>
                  <a:srgbClr val="000000"/>
                </a:solidFill>
                <a:latin typeface="Arial"/>
                <a:cs typeface="Arial"/>
              </a:rPr>
              <a:t>Process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05831" y="3109900"/>
            <a:ext cx="2828524" cy="600164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87313" indent="-87313"/>
            <a:r>
              <a:rPr lang="en-GB" sz="1100" dirty="0">
                <a:latin typeface="Arial"/>
                <a:cs typeface="Arial"/>
              </a:rPr>
              <a:t>Direct communication with HCPs</a:t>
            </a:r>
          </a:p>
          <a:p>
            <a:pPr marL="87313" indent="-87313"/>
            <a:r>
              <a:rPr lang="en-GB" sz="1100" dirty="0">
                <a:latin typeface="Arial"/>
                <a:cs typeface="Arial"/>
              </a:rPr>
              <a:t>HCP awareness to enable shorter discussion with patient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81263" y="1674688"/>
            <a:ext cx="2762712" cy="600164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87313" indent="-87313"/>
            <a:r>
              <a:rPr lang="en-GB" sz="1100" dirty="0">
                <a:latin typeface="Arial"/>
                <a:cs typeface="Arial"/>
              </a:rPr>
              <a:t>Patient access to records, HCPs and diagnostic tests</a:t>
            </a:r>
          </a:p>
          <a:p>
            <a:pPr marL="87313" indent="-87313"/>
            <a:r>
              <a:rPr lang="en-GB" sz="1100" dirty="0">
                <a:latin typeface="Arial"/>
                <a:cs typeface="Arial"/>
              </a:rPr>
              <a:t>Able to get psychological help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593981" y="682081"/>
            <a:ext cx="2725773" cy="769441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87313" indent="-87313"/>
            <a:r>
              <a:rPr lang="en-GB" sz="1100" dirty="0">
                <a:latin typeface="Arial"/>
                <a:cs typeface="Arial"/>
              </a:rPr>
              <a:t>Disease awareness</a:t>
            </a:r>
          </a:p>
          <a:p>
            <a:pPr marL="87313" indent="-87313"/>
            <a:r>
              <a:rPr lang="en-GB" sz="1100" dirty="0">
                <a:latin typeface="Arial"/>
                <a:cs typeface="Arial"/>
              </a:rPr>
              <a:t>Trusted information</a:t>
            </a:r>
          </a:p>
          <a:p>
            <a:pPr marL="87313" indent="-87313"/>
            <a:r>
              <a:rPr lang="en-GB" sz="1100" dirty="0">
                <a:latin typeface="Arial"/>
                <a:cs typeface="Arial"/>
              </a:rPr>
              <a:t>Awareness of own growth</a:t>
            </a:r>
          </a:p>
          <a:p>
            <a:pPr marL="87313" indent="-87313"/>
            <a:r>
              <a:rPr lang="en-GB" sz="1100" dirty="0">
                <a:latin typeface="Arial"/>
                <a:cs typeface="Arial"/>
              </a:rPr>
              <a:t>GP awareness of growth specialists</a:t>
            </a:r>
          </a:p>
        </p:txBody>
      </p:sp>
      <p:sp>
        <p:nvSpPr>
          <p:cNvPr id="12" name="Oval 11"/>
          <p:cNvSpPr>
            <a:spLocks noChangeAspect="1"/>
          </p:cNvSpPr>
          <p:nvPr/>
        </p:nvSpPr>
        <p:spPr>
          <a:xfrm>
            <a:off x="7481936" y="1894443"/>
            <a:ext cx="1080000" cy="1080000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100">
                <a:solidFill>
                  <a:srgbClr val="000000"/>
                </a:solidFill>
                <a:latin typeface="Arial"/>
                <a:cs typeface="Arial"/>
              </a:rPr>
              <a:t>Clinical/ Diagnostic</a:t>
            </a:r>
          </a:p>
        </p:txBody>
      </p:sp>
      <p:sp>
        <p:nvSpPr>
          <p:cNvPr id="13" name="Oval 12"/>
          <p:cNvSpPr>
            <a:spLocks noChangeAspect="1"/>
          </p:cNvSpPr>
          <p:nvPr/>
        </p:nvSpPr>
        <p:spPr>
          <a:xfrm>
            <a:off x="7481937" y="3193398"/>
            <a:ext cx="1080000" cy="1080000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100">
                <a:solidFill>
                  <a:srgbClr val="000000"/>
                </a:solidFill>
                <a:latin typeface="Arial"/>
                <a:cs typeface="Arial"/>
              </a:rPr>
              <a:t>Process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8742271" y="3212641"/>
            <a:ext cx="2762712" cy="600164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87313" indent="-87313"/>
            <a:r>
              <a:rPr lang="en-GB" sz="1100" dirty="0">
                <a:latin typeface="Arial"/>
                <a:cs typeface="Arial"/>
              </a:rPr>
              <a:t>Logistics regarding communication and feedback</a:t>
            </a:r>
          </a:p>
          <a:p>
            <a:pPr marL="87313" indent="-87313"/>
            <a:r>
              <a:rPr lang="en-GB" sz="1100" dirty="0">
                <a:latin typeface="Arial"/>
                <a:cs typeface="Arial"/>
              </a:rPr>
              <a:t>Time and distance factors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8750360" y="2075707"/>
            <a:ext cx="2762712" cy="430887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87313" indent="-87313"/>
            <a:r>
              <a:rPr lang="en-GB" sz="1100" dirty="0">
                <a:latin typeface="Arial"/>
                <a:cs typeface="Arial"/>
              </a:rPr>
              <a:t>Anxieties regarding both therapy and lack of therapy</a:t>
            </a:r>
          </a:p>
        </p:txBody>
      </p:sp>
      <p:sp>
        <p:nvSpPr>
          <p:cNvPr id="16" name="Oval 15"/>
          <p:cNvSpPr>
            <a:spLocks noChangeAspect="1"/>
          </p:cNvSpPr>
          <p:nvPr/>
        </p:nvSpPr>
        <p:spPr>
          <a:xfrm>
            <a:off x="6539097" y="4644646"/>
            <a:ext cx="1080000" cy="1080000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100">
                <a:solidFill>
                  <a:srgbClr val="000000"/>
                </a:solidFill>
                <a:latin typeface="Arial"/>
                <a:cs typeface="Arial"/>
              </a:rPr>
              <a:t>Education</a:t>
            </a:r>
          </a:p>
        </p:txBody>
      </p:sp>
      <p:sp>
        <p:nvSpPr>
          <p:cNvPr id="18" name="Oval 17"/>
          <p:cNvSpPr>
            <a:spLocks noChangeAspect="1"/>
          </p:cNvSpPr>
          <p:nvPr/>
        </p:nvSpPr>
        <p:spPr>
          <a:xfrm>
            <a:off x="4076162" y="4952549"/>
            <a:ext cx="1080000" cy="1080000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100">
                <a:solidFill>
                  <a:srgbClr val="000000"/>
                </a:solidFill>
                <a:latin typeface="Arial"/>
                <a:cs typeface="Arial"/>
              </a:rPr>
              <a:t>Process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854722" y="5273274"/>
            <a:ext cx="2955127" cy="600164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87313" indent="-87313"/>
            <a:r>
              <a:rPr lang="en-GB" sz="1100" dirty="0">
                <a:latin typeface="Arial"/>
                <a:cs typeface="Arial"/>
              </a:rPr>
              <a:t>Automated tools for monitoring growth</a:t>
            </a:r>
          </a:p>
          <a:p>
            <a:pPr marL="87313" indent="-87313"/>
            <a:r>
              <a:rPr lang="en-GB" sz="1100" dirty="0">
                <a:latin typeface="Arial"/>
                <a:cs typeface="Arial"/>
              </a:rPr>
              <a:t>Apps and alerts for deflection of growth</a:t>
            </a:r>
          </a:p>
          <a:p>
            <a:pPr marL="87313" indent="-87313"/>
            <a:r>
              <a:rPr lang="en-GB" sz="1100" dirty="0">
                <a:latin typeface="Arial"/>
                <a:cs typeface="Arial"/>
              </a:rPr>
              <a:t>Access to and interaction with HCPs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7971072" y="5202820"/>
            <a:ext cx="2974370" cy="769441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87313" indent="-87313"/>
            <a:r>
              <a:rPr lang="en-GB" sz="1100" dirty="0">
                <a:latin typeface="Arial"/>
                <a:cs typeface="Arial"/>
              </a:rPr>
              <a:t>Awareness of online tools </a:t>
            </a:r>
            <a:r>
              <a:rPr lang="mr-IN" sz="1100" dirty="0">
                <a:latin typeface="Arial"/>
                <a:cs typeface="Arial"/>
              </a:rPr>
              <a:t>–</a:t>
            </a:r>
            <a:r>
              <a:rPr lang="en-GB" sz="1100" dirty="0">
                <a:latin typeface="Arial"/>
                <a:cs typeface="Arial"/>
              </a:rPr>
              <a:t> apps, websites, medical portals, search resources</a:t>
            </a:r>
          </a:p>
          <a:p>
            <a:pPr marL="87313" indent="-87313"/>
            <a:r>
              <a:rPr lang="en-GB" sz="1100" dirty="0">
                <a:latin typeface="Arial"/>
                <a:cs typeface="Arial"/>
              </a:rPr>
              <a:t>GP awareness of growth specialists</a:t>
            </a:r>
          </a:p>
          <a:p>
            <a:pPr marL="87313" indent="-87313"/>
            <a:r>
              <a:rPr lang="en-GB" sz="1100" dirty="0">
                <a:latin typeface="Arial"/>
                <a:cs typeface="Arial"/>
              </a:rPr>
              <a:t>Remote training</a:t>
            </a:r>
          </a:p>
        </p:txBody>
      </p:sp>
      <p:sp>
        <p:nvSpPr>
          <p:cNvPr id="22" name="Oval 21"/>
          <p:cNvSpPr>
            <a:spLocks noChangeAspect="1"/>
          </p:cNvSpPr>
          <p:nvPr/>
        </p:nvSpPr>
        <p:spPr>
          <a:xfrm>
            <a:off x="6470178" y="1152007"/>
            <a:ext cx="1080000" cy="1080000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100" dirty="0">
                <a:solidFill>
                  <a:srgbClr val="000000"/>
                </a:solidFill>
                <a:latin typeface="Arial"/>
                <a:cs typeface="Arial"/>
              </a:rPr>
              <a:t>Education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7873331" y="765580"/>
            <a:ext cx="2762712" cy="769441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87313" indent="-87313"/>
            <a:r>
              <a:rPr lang="en-GB" sz="1100" dirty="0">
                <a:latin typeface="Arial"/>
                <a:cs typeface="Arial"/>
              </a:rPr>
              <a:t>Lack of knowledge about the referral and diagnostic pathways</a:t>
            </a:r>
          </a:p>
          <a:p>
            <a:pPr marL="87313" indent="-87313"/>
            <a:r>
              <a:rPr lang="en-GB" sz="1100" dirty="0">
                <a:latin typeface="Arial"/>
                <a:cs typeface="Arial"/>
              </a:rPr>
              <a:t>Lack of knowledge of disease nature and consequences</a:t>
            </a:r>
          </a:p>
        </p:txBody>
      </p:sp>
      <p:cxnSp>
        <p:nvCxnSpPr>
          <p:cNvPr id="24" name="Straight Connector 23"/>
          <p:cNvCxnSpPr/>
          <p:nvPr/>
        </p:nvCxnSpPr>
        <p:spPr>
          <a:xfrm flipH="1">
            <a:off x="5111304" y="5135721"/>
            <a:ext cx="240530" cy="125077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>
            <a:stCxn id="21" idx="1"/>
          </p:cNvCxnSpPr>
          <p:nvPr/>
        </p:nvCxnSpPr>
        <p:spPr>
          <a:xfrm flipH="1" flipV="1">
            <a:off x="7562204" y="5423270"/>
            <a:ext cx="408868" cy="164271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/>
          <p:cNvCxnSpPr/>
          <p:nvPr/>
        </p:nvCxnSpPr>
        <p:spPr>
          <a:xfrm flipH="1">
            <a:off x="7475281" y="1058100"/>
            <a:ext cx="400807" cy="357325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/>
          <p:cNvCxnSpPr>
            <a:stCxn id="11" idx="3"/>
          </p:cNvCxnSpPr>
          <p:nvPr/>
        </p:nvCxnSpPr>
        <p:spPr>
          <a:xfrm>
            <a:off x="4319754" y="1066802"/>
            <a:ext cx="253302" cy="348623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3" name="Oval 42"/>
          <p:cNvSpPr>
            <a:spLocks noChangeAspect="1"/>
          </p:cNvSpPr>
          <p:nvPr/>
        </p:nvSpPr>
        <p:spPr>
          <a:xfrm>
            <a:off x="5279869" y="5550903"/>
            <a:ext cx="1080000" cy="1080000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100" dirty="0">
                <a:solidFill>
                  <a:srgbClr val="000000"/>
                </a:solidFill>
                <a:latin typeface="Arial"/>
                <a:cs typeface="Arial"/>
              </a:rPr>
              <a:t>Clinical/ Diagnostic</a:t>
            </a:r>
          </a:p>
        </p:txBody>
      </p:sp>
    </p:spTree>
    <p:extLst>
      <p:ext uri="{BB962C8B-B14F-4D97-AF65-F5344CB8AC3E}">
        <p14:creationId xmlns:p14="http://schemas.microsoft.com/office/powerpoint/2010/main" val="9551253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22</TotalTime>
  <Words>136</Words>
  <Application>Microsoft Macintosh PowerPoint</Application>
  <PresentationFormat>Custom</PresentationFormat>
  <Paragraphs>3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rat Bagha</dc:creator>
  <cp:lastModifiedBy>Peter Bates</cp:lastModifiedBy>
  <cp:revision>128</cp:revision>
  <dcterms:created xsi:type="dcterms:W3CDTF">2020-06-30T04:52:24Z</dcterms:created>
  <dcterms:modified xsi:type="dcterms:W3CDTF">2021-01-26T13:16:21Z</dcterms:modified>
</cp:coreProperties>
</file>